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6" r:id="rId2"/>
    <p:sldId id="277" r:id="rId3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29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60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402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604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391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147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108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500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503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475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9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131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F7E66C-79D7-45D0-9E60-75345F7A986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91C13-E7D0-45B3-B6AD-00912832E1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479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68A1A33-11C1-4AAF-9C54-C99080B565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7466651"/>
              </p:ext>
            </p:extLst>
          </p:nvPr>
        </p:nvGraphicFramePr>
        <p:xfrm>
          <a:off x="523127" y="1023697"/>
          <a:ext cx="3035619" cy="8614642"/>
        </p:xfrm>
        <a:graphic>
          <a:graphicData uri="http://schemas.openxmlformats.org/drawingml/2006/table">
            <a:tbl>
              <a:tblPr/>
              <a:tblGrid>
                <a:gridCol w="259406">
                  <a:extLst>
                    <a:ext uri="{9D8B030D-6E8A-4147-A177-3AD203B41FA5}">
                      <a16:colId xmlns:a16="http://schemas.microsoft.com/office/drawing/2014/main" val="2181939684"/>
                    </a:ext>
                  </a:extLst>
                </a:gridCol>
                <a:gridCol w="793203">
                  <a:extLst>
                    <a:ext uri="{9D8B030D-6E8A-4147-A177-3AD203B41FA5}">
                      <a16:colId xmlns:a16="http://schemas.microsoft.com/office/drawing/2014/main" val="2227133769"/>
                    </a:ext>
                  </a:extLst>
                </a:gridCol>
                <a:gridCol w="235195">
                  <a:extLst>
                    <a:ext uri="{9D8B030D-6E8A-4147-A177-3AD203B41FA5}">
                      <a16:colId xmlns:a16="http://schemas.microsoft.com/office/drawing/2014/main" val="4067918523"/>
                    </a:ext>
                  </a:extLst>
                </a:gridCol>
                <a:gridCol w="332040">
                  <a:extLst>
                    <a:ext uri="{9D8B030D-6E8A-4147-A177-3AD203B41FA5}">
                      <a16:colId xmlns:a16="http://schemas.microsoft.com/office/drawing/2014/main" val="2363508888"/>
                    </a:ext>
                  </a:extLst>
                </a:gridCol>
                <a:gridCol w="793203">
                  <a:extLst>
                    <a:ext uri="{9D8B030D-6E8A-4147-A177-3AD203B41FA5}">
                      <a16:colId xmlns:a16="http://schemas.microsoft.com/office/drawing/2014/main" val="3374835183"/>
                    </a:ext>
                  </a:extLst>
                </a:gridCol>
                <a:gridCol w="622572">
                  <a:extLst>
                    <a:ext uri="{9D8B030D-6E8A-4147-A177-3AD203B41FA5}">
                      <a16:colId xmlns:a16="http://schemas.microsoft.com/office/drawing/2014/main" val="2899104220"/>
                    </a:ext>
                  </a:extLst>
                </a:gridCol>
              </a:tblGrid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alog #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pound Na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.W.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 #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rget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hwa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986131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G-459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2.3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8118-40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F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46797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1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intedanib (BIBF 112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9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6247-17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PDGFR,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326343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1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fatinib (BIBW299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5.9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9081-18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,HER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86101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1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ovitinib (TKI-258, CHIR-25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2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169-16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R,FLT3,c-Kit,VEGFR,PD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46558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rlotinib HCl (OSI-74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9.9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3319-69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tophagy,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48728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otesanib Diphosphate (AMG-706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9.4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7876-30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PDGFR,c-Ki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199140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VP-AEW54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9.5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489-16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-1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258627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4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orafenib Tosyl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7.0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207-59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GFR,Raf,V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2345724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4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emsirolimus (CCI-779, NSC 68386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0.2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2635-04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018246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batoclax Mesylate (GX15-07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3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3712-79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l-2,Autopha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603156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6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utlin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1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0090-7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3 Ligase ,Mdm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210018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HA-66575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1.6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7575-56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-Me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79048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7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HA14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9.2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673-63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l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866578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8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elinostat (PXD101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8.3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4864-00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186110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0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LN805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6.8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9363-13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022935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0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SU-03012 (AR-1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0.4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2112-33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K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85944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1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arespladib (LY31592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0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2732-68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lipase (e.g. PLA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980737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1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69069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5.4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7174-76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k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22228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1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danacatib (MK-082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3139-19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hepsin 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73553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abozantinib (XL184, BMS-907351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1.5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9217-68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T3,Tie-2,c-Kit,c-Met,VEGFR,Ax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395797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2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7548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1350-96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-1R,Trk receptor,c-Me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2524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2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RT172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6.0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1645-58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rtu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31819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rivanib Alaninate (BMS-58266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1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9735-63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576394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3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DL5859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8.9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0173-95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pioid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250363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4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17-AAG (Tanespimycin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5.6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747-14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P (e.g. HSP9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337837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4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vacaftor (VX-77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2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3054-44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FT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667538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4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7.8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4977-2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tubule Associate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98984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5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3I-2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5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1919-59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758981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apecitabin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9.3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4361-50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752620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EP-18770 (Delanzomib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3.2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7499-27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o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404513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K-824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7.2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0612-9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hydroge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631949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6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BT-751 (E701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4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1430-65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tubule Associate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147772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6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ispla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0.0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663-27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478034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7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K-2866 (GTx-02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9.3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1205-47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drogen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618906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7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egorafenib (BAY 73-4506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2.8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5037-03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-RET,V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262837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8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NMD-207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5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4353-76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,FLT3,V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197724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8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IBR 15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1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1674-73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lom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163304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9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UDC-1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4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12054-59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,HER2,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480402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9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AK-700 (Orteronel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7.3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6219-18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450 (e.g. CYP17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12776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rinoteca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6.6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7682-44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poisom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965616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0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ecitabi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8.2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53-33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407816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1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elarabin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7.2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032-29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284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1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leomycin Sulf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12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41-93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210419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2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KU-006379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5.5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8440-64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56931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gomelati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3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8112-76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HT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036451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4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JNJ-77066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4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3797-96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,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674366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ienoges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1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928-58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strogen/progestogen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410547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ufinami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8.1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6308-44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dium Channe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900035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vagacestat (BMS-708163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0.8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46699-66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mma-secretase,Beta Amyloi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948637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6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D17307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3.6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9580-11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376431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1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Ki1642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4.9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5025-24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A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919727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2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examethasone (DHAP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2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-02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tophagy,IL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497778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inkgolide 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4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291-77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69392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5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osartan Potassium (DuP 753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2.0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750-99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A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712382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igosertib (ON-0191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3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5497-78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558857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7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uxolitinib (INCB01842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6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1678-49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95774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8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afamostat Mesyl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9.5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956-11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o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765384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9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rarubic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7.6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496-41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poisom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822964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0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rilosta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9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647-35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hydroge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61661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2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roxino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3.6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9873-43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767094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2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anolazine 2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0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635-56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um Channe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05475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3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ildenafil Citr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6.7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1599-83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208617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spinesib (SB-71599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7.0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6113-53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ines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663947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ipifarnib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9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2185-72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442855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ilomilas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3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3259-65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486421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Zibotentan (ZD405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4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6497-07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thelin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405548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648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8.4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3900-33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9938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7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afinamide Mesyl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8.4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2825-46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O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241108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7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429286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2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4082-47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OC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560295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7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B5253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3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559-20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259338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8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Zosuquidar (LY335979) 3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6.9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7465-36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g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550039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8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HA-79388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1.4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8630-59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864238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8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K-9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9.8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3960-11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083212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9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onatinib (AP2453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2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3319-7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GFR,FGFR,VEGFR,Bcr-Ab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889046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9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Y222882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2.7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2507-23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38 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45559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ycophenolate Mofeti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3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8794-94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hydroge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831990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2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sedostat (CHR2797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8750-77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inopeptid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917392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2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Y281137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94044-20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ta Amyloid,Gamma-secret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041323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3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406 (free base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0.4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1290-80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144993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3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P-6734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7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3787-29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78351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3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MXAA (Vadimezan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2.2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570-53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D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581564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4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apaglifloz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8.8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432-26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GL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254683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5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805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5.5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9298-09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771190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T786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7.8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7531-00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6 Kinase,Ak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858519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6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7776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2.8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5720-94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xl,c-Me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349709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6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omalidomi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3.2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171-19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F-alph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9655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KU-600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7.6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5701-49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/AT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182143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7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ie2 kinase inhibi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9.5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8557-43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e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91452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9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pixaba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9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3612-47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ctor X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662390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63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llopurinol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6.1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5-30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X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372108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6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nalaprilat Dihydr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680-54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A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896461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70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ivalproex Sodiu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0.4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584-7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topha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28030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80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cadesi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8.2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27-69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787526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8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ithromyc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8.9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905-01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topha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248076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90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luvastatin Sodiu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3.4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957-5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MG-CoA Reduct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941937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98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denine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1.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22-28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499804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1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F-57322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1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9288-64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82764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2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Uridi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4.2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-96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146794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7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oexipril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5.0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586-52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A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46292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4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129226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6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2823-75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512727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DE225 (NVP-LDE225,Erismodegib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5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6697-53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dgehog/Smoothene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s &amp;  Wn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795314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5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GS 21680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5.9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431-80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alpha Reduct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161310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6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osuvastatin Calciu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0.5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7098-20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A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922321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ivinostat (ITF2357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.9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2302-99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921408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7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G-1436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8543-09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181091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7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Y278454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9.9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9236-86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874916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GI-1776 free b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5065-69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547040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9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liskiren Hemifumar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9.8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3334-58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A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188398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K-29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7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0185-01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524476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1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 96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4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5586-69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073483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YT38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4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6634-68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62586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2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UK 38336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4.3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622-88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collagen C Prote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73954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2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A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2.4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1-47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3 Ligase ,AP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70810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2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X-76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9.0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3404-37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330649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3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someprazole Sodium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7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1796-78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079261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4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KM120 (NVP-BKM120, Buparlisib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4396-07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175057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34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(-)-Parthenoli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8.3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554-84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3 Ligas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171415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44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orskol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575-29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M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805023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0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ioxolo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8.1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91-65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nic Anhyd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717895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54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2306-29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068219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2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Y260361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6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1222-4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088293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3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URB59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8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6141-08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AH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470974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37880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7263-13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120/CD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239706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CG-0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8.6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0757-88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nt/beta-caten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s &amp;  Wn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271800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7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rametinib (GSK112021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5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1700-17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48376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7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92250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8.4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9122-11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735205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8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brutinib (PCI-32765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0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6563-96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T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21418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9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XL3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8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9664-81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X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76518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0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Y210976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1.5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0874-71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347782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2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B41528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9.7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4218-23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K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35648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AC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2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5183-21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632209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lectinib (CH542480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2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56580-46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308684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7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B7054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9.2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1951-42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PV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819589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7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ocodazo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1.3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430-18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tubule Associated,Autopha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173283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7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F-52748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6.9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73615-35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dgehog/Smoothene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s &amp;  Wn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098541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8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-BET151 (GSK1210151A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5.4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0031-49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 Reader Doma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00216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9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otrastaur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8.4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5637-18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587007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9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rcetrapi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0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2352-17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T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330460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9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onafarni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.8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3275-84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977777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0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aletero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8.5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1983-8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450 (e.g. CYP17),Androgen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90000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0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irtino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4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536-97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rtu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50206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abrafenib (GSK2118436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9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95765-45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f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93855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0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DC-006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8.0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1264-89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k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03045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1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NK 128 (MLN012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9.3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4844-3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7798011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1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I994 (Tacedinaline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9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2522-64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667372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G10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.3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208-26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erase,DNA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328260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ideglusi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5854-05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K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454940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2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L133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3.8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2781-70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tassium Channe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120892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AR13167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8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33953-83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912589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I-D18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1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1437-28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6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90596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K-801 (Dizocilpine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1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086-21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21271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5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olvatinib (E705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3.6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8037-13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c-Me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1346930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6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loglip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0649-61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PP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1380966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0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umiracoxi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3.7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0991-2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X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535090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rfenido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5.2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179-13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F-beta/Sma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518769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1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Z81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0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778-02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XC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106200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1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W96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6.6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978-2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A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076647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poptosis Activator 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6.1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9183-19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2608185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300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Zaltoprofe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8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711-43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X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882418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1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Hyoscyami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9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1-31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h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1006388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lcapo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3.2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308-13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2391952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3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ethazolami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6.2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4-57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rbonic Anhyd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026764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7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Zinc Pyrithio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.7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63-41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on Pum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9587833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7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icagrel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2.5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4693-27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2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260167"/>
                  </a:ext>
                </a:extLst>
              </a:tr>
              <a:tr h="515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8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ulfacetamide Sodiu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6.2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7-56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topha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554051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8AFBA2FC-980B-4C04-953C-49B3A0D2AA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900453"/>
              </p:ext>
            </p:extLst>
          </p:nvPr>
        </p:nvGraphicFramePr>
        <p:xfrm>
          <a:off x="3922032" y="1023697"/>
          <a:ext cx="3035618" cy="8614570"/>
        </p:xfrm>
        <a:graphic>
          <a:graphicData uri="http://schemas.openxmlformats.org/drawingml/2006/table">
            <a:tbl>
              <a:tblPr/>
              <a:tblGrid>
                <a:gridCol w="259404">
                  <a:extLst>
                    <a:ext uri="{9D8B030D-6E8A-4147-A177-3AD203B41FA5}">
                      <a16:colId xmlns:a16="http://schemas.microsoft.com/office/drawing/2014/main" val="956205246"/>
                    </a:ext>
                  </a:extLst>
                </a:gridCol>
                <a:gridCol w="793204">
                  <a:extLst>
                    <a:ext uri="{9D8B030D-6E8A-4147-A177-3AD203B41FA5}">
                      <a16:colId xmlns:a16="http://schemas.microsoft.com/office/drawing/2014/main" val="3772586514"/>
                    </a:ext>
                  </a:extLst>
                </a:gridCol>
                <a:gridCol w="235195">
                  <a:extLst>
                    <a:ext uri="{9D8B030D-6E8A-4147-A177-3AD203B41FA5}">
                      <a16:colId xmlns:a16="http://schemas.microsoft.com/office/drawing/2014/main" val="2061319038"/>
                    </a:ext>
                  </a:extLst>
                </a:gridCol>
                <a:gridCol w="332039">
                  <a:extLst>
                    <a:ext uri="{9D8B030D-6E8A-4147-A177-3AD203B41FA5}">
                      <a16:colId xmlns:a16="http://schemas.microsoft.com/office/drawing/2014/main" val="3045617290"/>
                    </a:ext>
                  </a:extLst>
                </a:gridCol>
                <a:gridCol w="793204">
                  <a:extLst>
                    <a:ext uri="{9D8B030D-6E8A-4147-A177-3AD203B41FA5}">
                      <a16:colId xmlns:a16="http://schemas.microsoft.com/office/drawing/2014/main" val="3000695987"/>
                    </a:ext>
                  </a:extLst>
                </a:gridCol>
                <a:gridCol w="622572">
                  <a:extLst>
                    <a:ext uri="{9D8B030D-6E8A-4147-A177-3AD203B41FA5}">
                      <a16:colId xmlns:a16="http://schemas.microsoft.com/office/drawing/2014/main" val="1122691600"/>
                    </a:ext>
                  </a:extLst>
                </a:gridCol>
              </a:tblGrid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alog #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pound Na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.W.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 #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rget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hwa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264030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0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PZ00568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9.6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96772-26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84151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1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DC-015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8.6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3652-48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A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475167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1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ZC248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4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59824-67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878889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 J4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3.9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73423-53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demethyl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62228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9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KY0211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6.8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18807-13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nt/beta-caten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s &amp;  Wn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485254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2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YR-4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8805-02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1 Activat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4307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3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2207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5.3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7819-59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131614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U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0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4245-33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546619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4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CI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3.9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675-13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U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786510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5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atimastat (BB-9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7.6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370-60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M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144459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divi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3.2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8967-87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ynam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489624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8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GI-51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2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55326-35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hydroge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711407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9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KI-144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6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2278-01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OC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78020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9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BeQ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0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7355-84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9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408512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1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kepinone-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5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1485-83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38 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741409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ras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7.0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1203-78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rr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16795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errostatin-1 (Fer-1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2.3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7174-05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rr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452365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6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M-10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9.8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17329-24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538957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6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olgicide 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4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39889-93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101994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7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GI-10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.5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0149-73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33407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7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uvorexant (MK-4305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.9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0377-33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X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049338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Hop-01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0.5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80432-32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100454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2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asisula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5.1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9055-62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85619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1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EP-3249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7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88910-76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SF-1R,Raf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189954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1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AK-4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60141-27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tassium Channe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46717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2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W07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1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318-84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A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5310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ortioxetine (Lu AA21004) HB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9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0203-27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HT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683293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2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mpagliflozin (BI 10773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.9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4070-44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GL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32020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2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ariquida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6.7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6873-63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g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317593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4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34554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5.3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5430-58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  <a:r>
                        <a:rPr lang="el-GR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/IK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-</a:t>
                      </a:r>
                      <a:r>
                        <a:rPr lang="el-GR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469211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4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BT-199 (GDC-0199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8.4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57044-4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l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374301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acitenta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8.2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1798-33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thelin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048623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276-0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8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0113-03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179932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asatini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.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2962-49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r-Abl,c-Kit,Sr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808335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G-490 (Tyrphostin B4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4.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550-3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,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739448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6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HI-P15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6.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1555-04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,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54037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5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64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5.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8968-36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Acet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996877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GC-CBP3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9.0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 Reader Doma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497207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6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TX01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1.9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2590-9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30177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7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UNC66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8.2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14241-44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B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92694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unitinib Mal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2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1031-54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PDGFR,c-Ki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12974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8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VP-ADW7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3.5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488-23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-1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521482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833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.2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9357-68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169453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6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148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.7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5666-88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215080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G-1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407-82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o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87591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3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PS-21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8.9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4035-33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035049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2126458 (GSK45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5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86062-66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,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106607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7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F-0056227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5.6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9791-3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236190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5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UDC-9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.5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9928-25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,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988134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6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ovitinib (TKI-258) Dilactic Acid 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2.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2433-84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GFR,FGFR,c-Kit,FLT3,V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945442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454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3.5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5270-39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29659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0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PE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3.2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206-92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791579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1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rin 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2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3001-51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/ATR,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153462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orin 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7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2998-36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tophagy,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860946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4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athepsin Inhibitor 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1.8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5120-65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713145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4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B269970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8.9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1901-57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HT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49638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9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F-56227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7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7907-75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146207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9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W4417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5.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4433-23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k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58044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8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LN090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6.5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8960-69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482179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0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Ki161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.9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5025-13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PA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829243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9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IOX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2.3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1398-72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F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9863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30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osentan Hydr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9.6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7212-55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thelin Recep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378738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360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etulinic aci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6.7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2-15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opoisom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297584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abozantinib malate (XL18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5.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40909-48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xl,V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981409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1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llylthioure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6.1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9-57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916055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vanafi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3.9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0784-47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504167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itamin D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6.6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-14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87273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6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itamin D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4.6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-97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365038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08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itamin A Acet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8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7-47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799448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24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odium ascorb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1.1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-03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20949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49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JNK-IN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7.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10880-22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N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801025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600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XY-0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1.3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8021-79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055444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4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AY 100039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0.4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3498-69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978669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6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P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1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2889-26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r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626829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6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M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2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1794-92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6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772654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7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ilengiti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8.6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8968-51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gr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827662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8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23344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2.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7911-45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K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303687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09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(-)-Blebbistat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2.3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6925-71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66108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CH77298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7.6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2183-80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040722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0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DC-00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0.5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82512-48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62753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1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383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9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7163-56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C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821123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2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3-Deazaneplanocin A (DZNeP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2.2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052-95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ne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371399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6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SR128129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6.3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8318-2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081445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5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D28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3.5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6424-2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K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891407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28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doxaba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8.0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0449-70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ctor X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24542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Z19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9.5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130100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JSH-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0.3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9886-87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-</a:t>
                      </a:r>
                      <a:r>
                        <a:rPr lang="el-GR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-</a:t>
                      </a:r>
                      <a:r>
                        <a:rPr lang="el-GR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845355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0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enovin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9.4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0315-80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,E3 Ligas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708201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RT062607 (P505-15, BIIB057)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9.9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70261-97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987176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premilast (CC-10004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0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8141-41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237225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U 036443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2.2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6086-78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2412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omeguatri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6.1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2441-08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Methyltransfe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265060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acritinib (SB151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2.5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7272-79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002662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6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abutoclax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0.7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8108-65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l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992149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7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ardoxolone Methy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5.6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8600-53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  <a:r>
                        <a:rPr lang="el-GR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/IK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-</a:t>
                      </a:r>
                      <a:r>
                        <a:rPr lang="el-GR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88491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4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E032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1.3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45251-22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663142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0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SMI-4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3.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8190-29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841073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1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53692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9.9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8740-43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-1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017450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9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SI-906 (Linsitinib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1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7160-71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F-1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203228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0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anusertib (PHA-73935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4.5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7318-97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-RET,FGFR,Bcr-Abl,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043967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1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albociclib (PD-0332991)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3.9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7022-32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92891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W-3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3.7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7877-35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l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415513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3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lisertib (MLN8237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8.9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8486-01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25658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T928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1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6466-04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,Aurora Kinase,Bcr-Ab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/STA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504569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17-DMAG (Alvespimycin)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3.2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7214-21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P (e.g. HSP9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35739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5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anetespib (STA-909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4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8216-25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P (e.g. HSP9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9937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7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JNJ-26854165 (Serdemetan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8.4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1202-45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,E3 Ligas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502477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7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linabulin (NPI-235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6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4272-27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D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417494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3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lupirtine male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0.3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507-6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298831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6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7070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4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9607-74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g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biolo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779748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6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afetinib (INNO-406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6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9212-16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r-Ab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496375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8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izoribin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9.2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924-49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/RNA Synth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A Damag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16248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9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elitinib (EKB-569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7.9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7933-82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64820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1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afilomycin A1(Baf-A1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2.8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899-5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on Pum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58645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urora A Inhibitor I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8.0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58838-45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052299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HA-68063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1.6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8493-79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96921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X-74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6.2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9410-46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38 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831810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7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SU-68 (SU6668, Orantinib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0.3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2916-29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PDGFR,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12247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7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W50151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3.5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318-70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A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6556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47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ligomycin A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91.0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9-13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040122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1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CT12920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7.0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2947-93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381484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2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K-177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0.6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5365-80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ee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90474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2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Quizartinib (AC220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.6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0769-58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T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77793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4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X 527 (Selisistat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8.7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843-98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rtu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509646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5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mobenda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.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150-27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875132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HT-4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9.6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91951-57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K-1,Ak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819624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7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S-181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6.9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97219-81-6 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001086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57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IRB 796 (Doramapimod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7.6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5983-48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38 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27237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67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lurbiprofen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4.2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04-49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890687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Elvitegravir (GS-9137, JTK-303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7.8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7761-98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g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biolo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08140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1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enidipine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2.0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599-74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um Channe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19565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4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ornoxica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8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374-39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X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237208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7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torvastatin Calcium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55.3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4523-03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MG-CoA Reduct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138274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0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Rasagiline Mesyl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7.3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1735-79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O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312229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2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icofelo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9.8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6897-06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X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n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708065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5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Neratinib (HKI-27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7.0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8387-09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R2,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206526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5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KW-244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2.4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0669-72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rora Kinase,Bcr-Abl,FLT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560286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8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LN22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1.0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72833-77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o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348901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8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LN970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7.12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01902-80-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om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as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29558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8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GJ398 (NVP-BGJ39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.4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2511-34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305924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8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ST-130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1.0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0500-29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417757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19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A-96649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4.3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4162-61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469923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0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79483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8.8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4046-72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FR,c-Met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237502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1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ubritinib (TAK 165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8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6017-09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R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416602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2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F-37165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4.4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8774-43-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Pase,Proton Pump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279015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K-29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9.5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0185-02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863322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olasertib (BI 6727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8.8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5038-65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5594456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2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alomid 529 (P529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4913-8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871169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mecamtiv mecarbil (CK-182745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1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3697-71-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membrane Transporter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1007950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2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OSI-0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.4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36890-98-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21192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2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ostamatinib (R788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0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1119-35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giogene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702697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2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ubastatin A HC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8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10693-92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pigenetic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8109184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3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AK-87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3.6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74598-80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ocrinology &amp; Hormone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4557159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6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Dolutegravir (GSK1349572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9.38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1375-16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gr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biology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489008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68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AY-60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4.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62159-35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00605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2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Lapatinib (GW-572016) Ditosylat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5.4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8082-77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R2,E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255309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3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anobinostat (LBH589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9.4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4950-80-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DAC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152475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0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PIK-7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.7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2196-77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,DNA-P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776872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24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Vinblastin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0.9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5-21-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crotubule Associate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oskeletal Signaling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71264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36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SK105961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3.36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8852-01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,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/Akt/mTO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4855123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05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Gimeracil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5.5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766-25-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hydroge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lism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0307525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3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Crenolanib (CP-868596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3.54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0220-88-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GFR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Tyrosine Kin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096058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3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MK-8776 (SCH 900776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6.25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1494-63-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,Chk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Cycl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3616277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13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BMS-8339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3.5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9734-66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dgehog/Smoothene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PCR &amp; G Protein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2176701"/>
                  </a:ext>
                </a:extLst>
              </a:tr>
              <a:tr h="518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7311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1" i="1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Q-VD-OPh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3.4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35695-98-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pase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977660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87F3BEA6-4EFD-4BD6-BC53-D56BAB909500}"/>
              </a:ext>
            </a:extLst>
          </p:cNvPr>
          <p:cNvSpPr txBox="1"/>
          <p:nvPr/>
        </p:nvSpPr>
        <p:spPr>
          <a:xfrm>
            <a:off x="5882033" y="71605"/>
            <a:ext cx="1220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6B9DD8C-3595-4A3E-8450-575F8EDCB4C4}"/>
              </a:ext>
            </a:extLst>
          </p:cNvPr>
          <p:cNvSpPr/>
          <p:nvPr/>
        </p:nvSpPr>
        <p:spPr>
          <a:xfrm>
            <a:off x="454338" y="568096"/>
            <a:ext cx="650331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Inhibitors (probes) in the combinatorial drug screen, their molecular targets and cellular pathways targeted. </a:t>
            </a:r>
          </a:p>
        </p:txBody>
      </p:sp>
    </p:spTree>
    <p:extLst>
      <p:ext uri="{BB962C8B-B14F-4D97-AF65-F5344CB8AC3E}">
        <p14:creationId xmlns:p14="http://schemas.microsoft.com/office/powerpoint/2010/main" val="24727014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A34FC00-C571-484E-9683-4DB1FAB1248F}"/>
              </a:ext>
            </a:extLst>
          </p:cNvPr>
          <p:cNvSpPr txBox="1"/>
          <p:nvPr/>
        </p:nvSpPr>
        <p:spPr>
          <a:xfrm>
            <a:off x="5882033" y="71605"/>
            <a:ext cx="1220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7674EE3-E22D-4D41-A143-A04F6B5BC28A}"/>
              </a:ext>
            </a:extLst>
          </p:cNvPr>
          <p:cNvSpPr/>
          <p:nvPr/>
        </p:nvSpPr>
        <p:spPr>
          <a:xfrm>
            <a:off x="454338" y="642238"/>
            <a:ext cx="650331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C50 values of single agent inhibitors (probes) and their combinations with IACS-010759 (IACS) derived from growth inhibition curves. Tables A through C represent results from Cell Titer Blue assay, and table D represents results from crystal violet staining. </a:t>
            </a: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60FCECDF-9F69-4809-A31F-754FB9D366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4347669"/>
              </p:ext>
            </p:extLst>
          </p:nvPr>
        </p:nvGraphicFramePr>
        <p:xfrm>
          <a:off x="577903" y="1798959"/>
          <a:ext cx="2642535" cy="219456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870271">
                  <a:extLst>
                    <a:ext uri="{9D8B030D-6E8A-4147-A177-3AD203B41FA5}">
                      <a16:colId xmlns:a16="http://schemas.microsoft.com/office/drawing/2014/main" val="2693751275"/>
                    </a:ext>
                  </a:extLst>
                </a:gridCol>
                <a:gridCol w="631770">
                  <a:extLst>
                    <a:ext uri="{9D8B030D-6E8A-4147-A177-3AD203B41FA5}">
                      <a16:colId xmlns:a16="http://schemas.microsoft.com/office/drawing/2014/main" val="1359191308"/>
                    </a:ext>
                  </a:extLst>
                </a:gridCol>
                <a:gridCol w="1140494">
                  <a:extLst>
                    <a:ext uri="{9D8B030D-6E8A-4147-A177-3AD203B41FA5}">
                      <a16:colId xmlns:a16="http://schemas.microsoft.com/office/drawing/2014/main" val="2747666342"/>
                    </a:ext>
                  </a:extLst>
                </a:gridCol>
              </a:tblGrid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375R1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C50 Value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2450108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nhibitor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ingl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/>
                        <a:t>Probe+IACS</a:t>
                      </a:r>
                      <a:endParaRPr 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2439054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ACS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09.6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-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83716741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T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76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7.6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5993317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KU600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98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7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9056773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GI51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3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9.5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1075768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UDC1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36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5.3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9101529"/>
                  </a:ext>
                </a:extLst>
              </a:tr>
              <a:tr h="27248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ST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00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4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8971"/>
                  </a:ext>
                </a:extLst>
              </a:tr>
            </a:tbl>
          </a:graphicData>
        </a:graphic>
      </p:graphicFrame>
      <p:graphicFrame>
        <p:nvGraphicFramePr>
          <p:cNvPr id="8" name="Table 6">
            <a:extLst>
              <a:ext uri="{FF2B5EF4-FFF2-40B4-BE49-F238E27FC236}">
                <a16:creationId xmlns:a16="http://schemas.microsoft.com/office/drawing/2014/main" id="{F7279C39-895F-4880-8574-993AAA446A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9960186"/>
              </p:ext>
            </p:extLst>
          </p:nvPr>
        </p:nvGraphicFramePr>
        <p:xfrm>
          <a:off x="3765956" y="1791819"/>
          <a:ext cx="2642536" cy="219456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959168">
                  <a:extLst>
                    <a:ext uri="{9D8B030D-6E8A-4147-A177-3AD203B41FA5}">
                      <a16:colId xmlns:a16="http://schemas.microsoft.com/office/drawing/2014/main" val="2693751275"/>
                    </a:ext>
                  </a:extLst>
                </a:gridCol>
                <a:gridCol w="606742">
                  <a:extLst>
                    <a:ext uri="{9D8B030D-6E8A-4147-A177-3AD203B41FA5}">
                      <a16:colId xmlns:a16="http://schemas.microsoft.com/office/drawing/2014/main" val="1359191308"/>
                    </a:ext>
                  </a:extLst>
                </a:gridCol>
                <a:gridCol w="1076626">
                  <a:extLst>
                    <a:ext uri="{9D8B030D-6E8A-4147-A177-3AD203B41FA5}">
                      <a16:colId xmlns:a16="http://schemas.microsoft.com/office/drawing/2014/main" val="2747666342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UCSD354L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C50 Value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245010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nhibitor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ingl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/>
                        <a:t>Probe+IACS</a:t>
                      </a:r>
                      <a:endParaRPr 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243905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ACS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403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-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8371674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T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23.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8.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599331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QZ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13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92.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905677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B5253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86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42.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107576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JNJ77066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66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30.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910152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ST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0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93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8971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09B3E54F-7EA4-4CD8-BA5B-AFD1A0B7BE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078870"/>
              </p:ext>
            </p:extLst>
          </p:nvPr>
        </p:nvGraphicFramePr>
        <p:xfrm>
          <a:off x="577904" y="4962670"/>
          <a:ext cx="2684280" cy="155448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06167">
                  <a:extLst>
                    <a:ext uri="{9D8B030D-6E8A-4147-A177-3AD203B41FA5}">
                      <a16:colId xmlns:a16="http://schemas.microsoft.com/office/drawing/2014/main" val="4257647716"/>
                    </a:ext>
                  </a:extLst>
                </a:gridCol>
                <a:gridCol w="740122">
                  <a:extLst>
                    <a:ext uri="{9D8B030D-6E8A-4147-A177-3AD203B41FA5}">
                      <a16:colId xmlns:a16="http://schemas.microsoft.com/office/drawing/2014/main" val="822218190"/>
                    </a:ext>
                  </a:extLst>
                </a:gridCol>
                <a:gridCol w="937991">
                  <a:extLst>
                    <a:ext uri="{9D8B030D-6E8A-4147-A177-3AD203B41FA5}">
                      <a16:colId xmlns:a16="http://schemas.microsoft.com/office/drawing/2014/main" val="1397822336"/>
                    </a:ext>
                  </a:extLst>
                </a:gridCol>
              </a:tblGrid>
              <a:tr h="3108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375R1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C50 Value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9755070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nhibitor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ingl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/>
                        <a:t>Probe+IACS</a:t>
                      </a:r>
                      <a:endParaRPr 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5603695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ACS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6.5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-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21766077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GSK6906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0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4.8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6080963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BKM1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6999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91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630889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008B1FF-1172-4256-836C-ECD3E9677EDA}"/>
              </a:ext>
            </a:extLst>
          </p:cNvPr>
          <p:cNvSpPr txBox="1"/>
          <p:nvPr/>
        </p:nvSpPr>
        <p:spPr>
          <a:xfrm>
            <a:off x="523501" y="13269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243E56-774E-4F82-8F87-EAB9A403CAFA}"/>
              </a:ext>
            </a:extLst>
          </p:cNvPr>
          <p:cNvSpPr txBox="1"/>
          <p:nvPr/>
        </p:nvSpPr>
        <p:spPr>
          <a:xfrm>
            <a:off x="3765956" y="13269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7B0B45-7196-48B3-B1ED-75BE0E3A9AF7}"/>
              </a:ext>
            </a:extLst>
          </p:cNvPr>
          <p:cNvSpPr txBox="1"/>
          <p:nvPr/>
        </p:nvSpPr>
        <p:spPr>
          <a:xfrm>
            <a:off x="523501" y="442677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A0A6CE17-94EB-49AF-9780-A754756C3D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8830166"/>
              </p:ext>
            </p:extLst>
          </p:nvPr>
        </p:nvGraphicFramePr>
        <p:xfrm>
          <a:off x="3925833" y="4962670"/>
          <a:ext cx="2482659" cy="1275904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16977">
                  <a:extLst>
                    <a:ext uri="{9D8B030D-6E8A-4147-A177-3AD203B41FA5}">
                      <a16:colId xmlns:a16="http://schemas.microsoft.com/office/drawing/2014/main" val="4257647716"/>
                    </a:ext>
                  </a:extLst>
                </a:gridCol>
                <a:gridCol w="766888">
                  <a:extLst>
                    <a:ext uri="{9D8B030D-6E8A-4147-A177-3AD203B41FA5}">
                      <a16:colId xmlns:a16="http://schemas.microsoft.com/office/drawing/2014/main" val="822218190"/>
                    </a:ext>
                  </a:extLst>
                </a:gridCol>
                <a:gridCol w="998794">
                  <a:extLst>
                    <a:ext uri="{9D8B030D-6E8A-4147-A177-3AD203B41FA5}">
                      <a16:colId xmlns:a16="http://schemas.microsoft.com/office/drawing/2014/main" val="1397822336"/>
                    </a:ext>
                  </a:extLst>
                </a:gridCol>
              </a:tblGrid>
              <a:tr h="3189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A375R1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C50 Value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9755070"/>
                  </a:ext>
                </a:extLst>
              </a:tr>
              <a:tr h="3189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nhibitor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ingl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/>
                        <a:t>Probe+IACS</a:t>
                      </a:r>
                      <a:endParaRPr 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5603695"/>
                  </a:ext>
                </a:extLst>
              </a:tr>
              <a:tr h="3189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IACS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4.8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-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21766077"/>
                  </a:ext>
                </a:extLst>
              </a:tr>
              <a:tr h="31897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T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9.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.8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6080963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FE603DBF-3A59-4CF5-A593-3BA7D7383DFD}"/>
              </a:ext>
            </a:extLst>
          </p:cNvPr>
          <p:cNvSpPr txBox="1"/>
          <p:nvPr/>
        </p:nvSpPr>
        <p:spPr>
          <a:xfrm>
            <a:off x="3706908" y="442677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026699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7</TotalTime>
  <Words>3198</Words>
  <Application>Microsoft Office PowerPoint</Application>
  <PresentationFormat>Custom</PresentationFormat>
  <Paragraphs>20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nnu Nanda,Vashisht Gopal</dc:creator>
  <cp:lastModifiedBy>Yennu Nanda,Vashisht Gopal</cp:lastModifiedBy>
  <cp:revision>12</cp:revision>
  <dcterms:created xsi:type="dcterms:W3CDTF">2021-07-26T18:55:08Z</dcterms:created>
  <dcterms:modified xsi:type="dcterms:W3CDTF">2021-12-02T06:33:48Z</dcterms:modified>
</cp:coreProperties>
</file>